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2376" y="1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6/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9876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9876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430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Hybridizing machine learning in survival analysis of cardiac PET/CT imaging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Luis Eduardo Juarez-Orozco MD, Ph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1,2,3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Mikael Niemi M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†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Ming Wai Yeung MSc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2†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Jan Walter Benjamins BSc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eemu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Maaniitty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MD, Ph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Jarmo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euho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Ph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prof. Antti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araste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MD, Ph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,4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prof. Juhani Knuuti M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prof. Pim van der Harst MD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prof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iku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Klén</a:t>
            </a:r>
            <a:r>
              <a:rPr lang="en-US" sz="1200" i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</a:p>
          <a:p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1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University Medical Center Utrecht 2 University Medical Center Groningen 3 Turku PET Centre, Finland 4</a:t>
            </a:r>
            <a:r>
              <a:rPr lang="en-NL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Heart Center, Turku University Hospital, Finland</a:t>
            </a:r>
            <a:endParaRPr lang="en-N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7B15039-B560-B145-9FE8-3B82EC1994C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1" t="6666" r="4863" b="3301"/>
          <a:stretch/>
        </p:blipFill>
        <p:spPr>
          <a:xfrm>
            <a:off x="1600200" y="3949703"/>
            <a:ext cx="1295400" cy="1841497"/>
          </a:xfrm>
          <a:prstGeom prst="rect">
            <a:avLst/>
          </a:prstGeom>
        </p:spPr>
      </p:pic>
      <p:pic>
        <p:nvPicPr>
          <p:cNvPr id="13" name="Picture 12" descr="UMC Utrecht Logo [ Download - Logo - icon ] png svg">
            <a:extLst>
              <a:ext uri="{FF2B5EF4-FFF2-40B4-BE49-F238E27FC236}">
                <a16:creationId xmlns:a16="http://schemas.microsoft.com/office/drawing/2014/main" id="{56C714F0-547D-0E41-8A22-77BD0F3E824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392" b="31477"/>
          <a:stretch/>
        </p:blipFill>
        <p:spPr bwMode="auto">
          <a:xfrm>
            <a:off x="5738004" y="4125271"/>
            <a:ext cx="1782792" cy="6619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3" descr="Turku PET Symposium 2022 | 3-6 June 2022 | Turku, Finland">
            <a:extLst>
              <a:ext uri="{FF2B5EF4-FFF2-40B4-BE49-F238E27FC236}">
                <a16:creationId xmlns:a16="http://schemas.microsoft.com/office/drawing/2014/main" id="{3D018DEA-9CB9-0F48-A703-C348638036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92679" y="5032801"/>
            <a:ext cx="1478310" cy="467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Machine learning allows the integration of PET/CT variables</a:t>
            </a:r>
          </a:p>
          <a:p>
            <a:pPr marL="0" indent="0">
              <a:buNone/>
            </a:pPr>
            <a:r>
              <a:rPr lang="en-US" altLang="en-US" sz="2800" dirty="0"/>
              <a:t>2- Traditional survival analysis provide explainable prognostic estimates</a:t>
            </a:r>
          </a:p>
          <a:p>
            <a:pPr marL="0" indent="0">
              <a:buNone/>
            </a:pPr>
            <a:r>
              <a:rPr lang="en-US" altLang="en-US" sz="2800" dirty="0"/>
              <a:t>3- Hybridization of machine learning-and-survival analysis for multimodal cardiac PET/CT data may help identify patients who develop myocardial infarction or death in a long term follow-up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Retrospective analysis of a prospective long term registry of cardiac water PET/C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Observation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intermediate risk patients with suspected coronary artery diseas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(s): all-cause mortality or myocardial infarction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(s): model performance (hybridized vs. expert-based vs. calcium score-based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ET (17 vars), CT (58 vars), clinical (7 vars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2E7DD59-FE42-5B42-82E9-9AEA9117B79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485" y="1524000"/>
            <a:ext cx="6369115" cy="4379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graphicFrame>
        <p:nvGraphicFramePr>
          <p:cNvPr id="2" name="Content Placeholder 1">
            <a:extLst>
              <a:ext uri="{FF2B5EF4-FFF2-40B4-BE49-F238E27FC236}">
                <a16:creationId xmlns:a16="http://schemas.microsoft.com/office/drawing/2014/main" id="{DDF2BA24-B64D-A34D-ADF8-1654542E38E1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95300" y="3014186"/>
          <a:ext cx="8229600" cy="13995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36487">
                  <a:extLst>
                    <a:ext uri="{9D8B030D-6E8A-4147-A177-3AD203B41FA5}">
                      <a16:colId xmlns:a16="http://schemas.microsoft.com/office/drawing/2014/main" val="757564564"/>
                    </a:ext>
                  </a:extLst>
                </a:gridCol>
                <a:gridCol w="1213695">
                  <a:extLst>
                    <a:ext uri="{9D8B030D-6E8A-4147-A177-3AD203B41FA5}">
                      <a16:colId xmlns:a16="http://schemas.microsoft.com/office/drawing/2014/main" val="599192300"/>
                    </a:ext>
                  </a:extLst>
                </a:gridCol>
                <a:gridCol w="1215519">
                  <a:extLst>
                    <a:ext uri="{9D8B030D-6E8A-4147-A177-3AD203B41FA5}">
                      <a16:colId xmlns:a16="http://schemas.microsoft.com/office/drawing/2014/main" val="693870053"/>
                    </a:ext>
                  </a:extLst>
                </a:gridCol>
                <a:gridCol w="1217342">
                  <a:extLst>
                    <a:ext uri="{9D8B030D-6E8A-4147-A177-3AD203B41FA5}">
                      <a16:colId xmlns:a16="http://schemas.microsoft.com/office/drawing/2014/main" val="3879309446"/>
                    </a:ext>
                  </a:extLst>
                </a:gridCol>
                <a:gridCol w="1214607">
                  <a:extLst>
                    <a:ext uri="{9D8B030D-6E8A-4147-A177-3AD203B41FA5}">
                      <a16:colId xmlns:a16="http://schemas.microsoft.com/office/drawing/2014/main" val="1358175589"/>
                    </a:ext>
                  </a:extLst>
                </a:gridCol>
                <a:gridCol w="1215519">
                  <a:extLst>
                    <a:ext uri="{9D8B030D-6E8A-4147-A177-3AD203B41FA5}">
                      <a16:colId xmlns:a16="http://schemas.microsoft.com/office/drawing/2014/main" val="2474995623"/>
                    </a:ext>
                  </a:extLst>
                </a:gridCol>
                <a:gridCol w="1216431">
                  <a:extLst>
                    <a:ext uri="{9D8B030D-6E8A-4147-A177-3AD203B41FA5}">
                      <a16:colId xmlns:a16="http://schemas.microsoft.com/office/drawing/2014/main" val="2971410469"/>
                    </a:ext>
                  </a:extLst>
                </a:gridCol>
              </a:tblGrid>
              <a:tr h="34988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Hybridized ML Model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Expert-based Model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Calcium score-based Model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4147543"/>
                  </a:ext>
                </a:extLst>
              </a:tr>
              <a:tr h="34988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 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rain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est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rain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est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rain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Testing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992696467"/>
                  </a:ext>
                </a:extLst>
              </a:tr>
              <a:tr h="34988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C-index 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85 (0.75-0.95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81 (0.67-0.95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72 (0.61-0.84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71 (0.55-0.87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65 (0.54-0.77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64 (0.49-0.79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190299169"/>
                  </a:ext>
                </a:extLst>
              </a:tr>
              <a:tr h="34988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AUROC 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89 (0.81-0.97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76 (0.63-0.93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76 (0.66-0.86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67 (0.50-0.84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>
                          <a:effectLst/>
                        </a:rPr>
                        <a:t>0.68 (0.59-0.78)</a:t>
                      </a:r>
                      <a:endParaRPr lang="en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i-FI" sz="1200" dirty="0">
                          <a:effectLst/>
                        </a:rPr>
                        <a:t>0.64(0.49-0.79)</a:t>
                      </a:r>
                      <a:endParaRPr lang="en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102795313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Prognostic modelling of cardiac PET/CT data for the long-term occurrence of MI and all-cause mortality can be improved through integration of imaging data into ML-based scores and subsequent survival analysis along with clinical variables. </a:t>
            </a:r>
          </a:p>
          <a:p>
            <a:pPr marL="0" indent="0">
              <a:buNone/>
            </a:pPr>
            <a:r>
              <a:rPr lang="en-US" altLang="en-US" sz="2800" dirty="0"/>
              <a:t>2- This hybridization of methods engages novel ML analytics in a more familiar way for clinicians, while offering an alternative to traditional survival modelling of conventional image interpretation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Words>476</Words>
  <Application>Microsoft Macintosh PowerPoint</Application>
  <PresentationFormat>On-screen Show (4:3)</PresentationFormat>
  <Paragraphs>5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Hybridizing machine learning in survival analysis of cardiac PET/CT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uis Eduardo Juarez-Orozco</cp:lastModifiedBy>
  <cp:revision>99</cp:revision>
  <dcterms:created xsi:type="dcterms:W3CDTF">2011-04-18T21:44:13Z</dcterms:created>
  <dcterms:modified xsi:type="dcterms:W3CDTF">2023-07-06T03:22:38Z</dcterms:modified>
</cp:coreProperties>
</file>